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6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B0E634B4-21A4-8E1E-ED11-F6794D24761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64490" y="938530"/>
            <a:ext cx="5731510" cy="498094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1A6DE8CF-CC4B-2423-E3E4-AE84A77E5432}"/>
              </a:ext>
            </a:extLst>
          </p:cNvPr>
          <p:cNvSpPr txBox="1"/>
          <p:nvPr/>
        </p:nvSpPr>
        <p:spPr>
          <a:xfrm>
            <a:off x="6705585" y="2501213"/>
            <a:ext cx="4824000" cy="18555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7. </a:t>
            </a:r>
            <a:r>
              <a:rPr lang="en-GB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ological replicate used for the quantification in Figure 2b. Wells A and B contain non-floated PC:NTA-Ni and PC:PE:NTA-Ni liposomes incubated with HR1-His peptides. Wells C and D contain the corresponding floated samples.  </a:t>
            </a:r>
            <a:endParaRPr lang="fr-FR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564105" y="3976771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474492" y="3976771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328732" y="3976771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134845" y="3976770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92045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48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2</cp:revision>
  <dcterms:created xsi:type="dcterms:W3CDTF">2023-08-01T09:01:08Z</dcterms:created>
  <dcterms:modified xsi:type="dcterms:W3CDTF">2023-08-02T09:19:08Z</dcterms:modified>
</cp:coreProperties>
</file>